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1" r:id="rId3"/>
    <p:sldId id="262" r:id="rId4"/>
    <p:sldId id="260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54" autoAdjust="0"/>
    <p:restoredTop sz="94660"/>
  </p:normalViewPr>
  <p:slideViewPr>
    <p:cSldViewPr snapToGrid="0">
      <p:cViewPr varScale="1">
        <p:scale>
          <a:sx n="62" d="100"/>
          <a:sy n="62" d="100"/>
        </p:scale>
        <p:origin x="267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848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6722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0506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790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0016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2471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3407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0133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7844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974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63476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30F5C2-9DB0-4F75-BE38-102F25C1B54E}" type="datetimeFigureOut">
              <a:rPr lang="en-GB" smtClean="0"/>
              <a:t>02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4876B9-F44F-47E1-918B-B6E6E039C73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2116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5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11" Type="http://schemas.openxmlformats.org/officeDocument/2006/relationships/image" Target="../media/image10.png"/><Relationship Id="rId5" Type="http://schemas.openxmlformats.org/officeDocument/2006/relationships/oleObject" Target="../embeddings/oleObject2.bin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4.emf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7372" y="250505"/>
            <a:ext cx="2459841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 dirty="0"/>
              <a:t>Supplementary Figure 1</a:t>
            </a:r>
            <a:endParaRPr lang="de-DE" sz="1801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2146" y="1234023"/>
            <a:ext cx="5295209" cy="1813977"/>
          </a:xfrm>
          <a:prstGeom prst="rect">
            <a:avLst/>
          </a:prstGeom>
        </p:spPr>
      </p:pic>
      <p:sp>
        <p:nvSpPr>
          <p:cNvPr id="6" name="CasellaDiTesto 1">
            <a:extLst>
              <a:ext uri="{FF2B5EF4-FFF2-40B4-BE49-F238E27FC236}">
                <a16:creationId xmlns:a16="http://schemas.microsoft.com/office/drawing/2014/main" id="{E40F1352-C1F5-E543-ABFB-B1BD9F2A63B8}"/>
              </a:ext>
            </a:extLst>
          </p:cNvPr>
          <p:cNvSpPr txBox="1"/>
          <p:nvPr/>
        </p:nvSpPr>
        <p:spPr>
          <a:xfrm>
            <a:off x="618707" y="864691"/>
            <a:ext cx="285332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8578575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9244" y="188673"/>
            <a:ext cx="2515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2</a:t>
            </a:r>
            <a:endParaRPr lang="de-DE" b="1" dirty="0"/>
          </a:p>
        </p:txBody>
      </p:sp>
      <p:pic>
        <p:nvPicPr>
          <p:cNvPr id="5" name="Immagine 1">
            <a:extLst>
              <a:ext uri="{FF2B5EF4-FFF2-40B4-BE49-F238E27FC236}">
                <a16:creationId xmlns:a16="http://schemas.microsoft.com/office/drawing/2014/main" id="{3C126DC9-F28C-834F-88AD-45E77FCDEE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623" y="1136201"/>
            <a:ext cx="6138713" cy="284964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92208" y="951535"/>
            <a:ext cx="431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2381582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5286" y="188089"/>
            <a:ext cx="2515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3</a:t>
            </a:r>
            <a:endParaRPr lang="de-DE" b="1" dirty="0"/>
          </a:p>
        </p:txBody>
      </p:sp>
      <p:pic>
        <p:nvPicPr>
          <p:cNvPr id="5" name="Immagine 2">
            <a:extLst>
              <a:ext uri="{FF2B5EF4-FFF2-40B4-BE49-F238E27FC236}">
                <a16:creationId xmlns:a16="http://schemas.microsoft.com/office/drawing/2014/main" id="{C46636F0-1D33-3D4A-891E-D936EF6A16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496" y="983272"/>
            <a:ext cx="6238173" cy="300406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41960" y="720084"/>
            <a:ext cx="431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6843418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9703" y="220327"/>
            <a:ext cx="2488695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 dirty="0"/>
              <a:t>Supplementary figure 4.</a:t>
            </a:r>
            <a:endParaRPr lang="de-DE" sz="1801" b="1" dirty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78933" y="1094544"/>
          <a:ext cx="3015305" cy="26592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9" r:id="rId3" imgW="3091765" imgH="2727447" progId="Prism9.Document">
                  <p:embed/>
                </p:oleObj>
              </mc:Choice>
              <mc:Fallback>
                <p:oleObj name="Prism 9" r:id="rId3" imgW="3091765" imgH="2727447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8933" y="1094544"/>
                        <a:ext cx="3015305" cy="26592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88814" y="909877"/>
            <a:ext cx="431842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/>
              <a:t>A</a:t>
            </a:r>
            <a:endParaRPr lang="de-DE" sz="1801" b="1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2898500" y="1279210"/>
          <a:ext cx="4054475" cy="24746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Prism 8" r:id="rId5" imgW="4480866" imgH="2735592" progId="Prism8.Document">
                  <p:embed/>
                </p:oleObj>
              </mc:Choice>
              <mc:Fallback>
                <p:oleObj name="Prism 8" r:id="rId5" imgW="4480866" imgH="2735592" progId="Prism8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98500" y="1279210"/>
                        <a:ext cx="4054475" cy="24746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381834" y="909877"/>
            <a:ext cx="314510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 dirty="0"/>
              <a:t>B</a:t>
            </a:r>
            <a:endParaRPr lang="de-DE" sz="1801" b="1" dirty="0"/>
          </a:p>
        </p:txBody>
      </p:sp>
      <p:pic>
        <p:nvPicPr>
          <p:cNvPr id="9" name="Picture 8"/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73" t="16956" r="26860" b="26079"/>
          <a:stretch/>
        </p:blipFill>
        <p:spPr>
          <a:xfrm>
            <a:off x="972393" y="4551909"/>
            <a:ext cx="1563625" cy="1325881"/>
          </a:xfrm>
          <a:prstGeom prst="rect">
            <a:avLst/>
          </a:prstGeom>
        </p:spPr>
      </p:pic>
      <p:pic>
        <p:nvPicPr>
          <p:cNvPr id="10" name="Picture 9"/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471" t="3051" r="3718" b="40592"/>
          <a:stretch/>
        </p:blipFill>
        <p:spPr>
          <a:xfrm>
            <a:off x="968699" y="5934798"/>
            <a:ext cx="1563625" cy="1325881"/>
          </a:xfrm>
          <a:prstGeom prst="rect">
            <a:avLst/>
          </a:prstGeom>
        </p:spPr>
      </p:pic>
      <p:pic>
        <p:nvPicPr>
          <p:cNvPr id="11" name="Picture 10"/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097" t="11800" r="8244" b="31505"/>
          <a:stretch/>
        </p:blipFill>
        <p:spPr>
          <a:xfrm>
            <a:off x="2566210" y="4551909"/>
            <a:ext cx="1563625" cy="1325881"/>
          </a:xfrm>
          <a:prstGeom prst="rect">
            <a:avLst/>
          </a:prstGeom>
        </p:spPr>
      </p:pic>
      <p:pic>
        <p:nvPicPr>
          <p:cNvPr id="12" name="Picture 11"/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68" t="21566" r="30725" b="21264"/>
          <a:stretch/>
        </p:blipFill>
        <p:spPr>
          <a:xfrm>
            <a:off x="2569509" y="5934798"/>
            <a:ext cx="1563625" cy="1325881"/>
          </a:xfrm>
          <a:prstGeom prst="rect">
            <a:avLst/>
          </a:prstGeom>
        </p:spPr>
      </p:pic>
      <p:pic>
        <p:nvPicPr>
          <p:cNvPr id="13" name="Picture 12"/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15" t="16954" r="22318" b="26622"/>
          <a:stretch/>
        </p:blipFill>
        <p:spPr>
          <a:xfrm>
            <a:off x="4160028" y="4551909"/>
            <a:ext cx="1563625" cy="1325881"/>
          </a:xfrm>
          <a:prstGeom prst="rect">
            <a:avLst/>
          </a:prstGeom>
        </p:spPr>
      </p:pic>
      <p:pic>
        <p:nvPicPr>
          <p:cNvPr id="14" name="Picture 13"/>
          <p:cNvPicPr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06" t="20142" r="12451" b="23299"/>
          <a:stretch/>
        </p:blipFill>
        <p:spPr>
          <a:xfrm>
            <a:off x="4157577" y="5934798"/>
            <a:ext cx="1563625" cy="1325881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 rot="16200000" flipH="1">
            <a:off x="474278" y="5038061"/>
            <a:ext cx="630556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/>
              <a:t>0 Gy</a:t>
            </a:r>
          </a:p>
        </p:txBody>
      </p:sp>
      <p:sp>
        <p:nvSpPr>
          <p:cNvPr id="16" name="TextBox 15"/>
          <p:cNvSpPr txBox="1"/>
          <p:nvPr/>
        </p:nvSpPr>
        <p:spPr>
          <a:xfrm rot="16200000" flipH="1">
            <a:off x="425893" y="6297124"/>
            <a:ext cx="805052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1" b="1" dirty="0"/>
              <a:t>4 Gy</a:t>
            </a:r>
          </a:p>
        </p:txBody>
      </p:sp>
      <p:sp>
        <p:nvSpPr>
          <p:cNvPr id="17" name="TextBox 16"/>
          <p:cNvSpPr txBox="1"/>
          <p:nvPr/>
        </p:nvSpPr>
        <p:spPr>
          <a:xfrm flipH="1">
            <a:off x="1244731" y="4220617"/>
            <a:ext cx="1173291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/>
              <a:t>Normoxia</a:t>
            </a:r>
          </a:p>
        </p:txBody>
      </p:sp>
      <p:sp>
        <p:nvSpPr>
          <p:cNvPr id="18" name="TextBox 17"/>
          <p:cNvSpPr txBox="1"/>
          <p:nvPr/>
        </p:nvSpPr>
        <p:spPr>
          <a:xfrm flipH="1">
            <a:off x="2845028" y="4220617"/>
            <a:ext cx="1173291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/>
              <a:t>Acute </a:t>
            </a:r>
            <a:r>
              <a:rPr lang="en-US" sz="1801" b="1" dirty="0" err="1"/>
              <a:t>Hyp</a:t>
            </a:r>
            <a:endParaRPr lang="en-US" sz="1801" b="1" dirty="0"/>
          </a:p>
        </p:txBody>
      </p:sp>
      <p:sp>
        <p:nvSpPr>
          <p:cNvPr id="19" name="TextBox 18"/>
          <p:cNvSpPr txBox="1"/>
          <p:nvPr/>
        </p:nvSpPr>
        <p:spPr>
          <a:xfrm flipH="1">
            <a:off x="4405605" y="4244310"/>
            <a:ext cx="1520859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 err="1"/>
              <a:t>Reoxy</a:t>
            </a:r>
            <a:r>
              <a:rPr lang="en-US" sz="1801" b="1" dirty="0"/>
              <a:t> </a:t>
            </a:r>
            <a:r>
              <a:rPr lang="en-US" sz="1801" b="1" dirty="0" err="1"/>
              <a:t>Hyp</a:t>
            </a:r>
            <a:endParaRPr lang="en-US" sz="1801" b="1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4925739" y="5795629"/>
            <a:ext cx="691468" cy="195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030229" y="5583130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500 µm</a:t>
            </a:r>
            <a:endParaRPr lang="de-DE" sz="8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62429" y="4212677"/>
            <a:ext cx="306494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 dirty="0"/>
              <a:t>C</a:t>
            </a:r>
            <a:endParaRPr lang="de-DE" sz="1801" b="1" dirty="0"/>
          </a:p>
        </p:txBody>
      </p:sp>
      <p:pic>
        <p:nvPicPr>
          <p:cNvPr id="23" name="Picture 22"/>
          <p:cNvPicPr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13" t="17498" r="22180" b="26147"/>
          <a:stretch/>
        </p:blipFill>
        <p:spPr>
          <a:xfrm>
            <a:off x="964729" y="8246247"/>
            <a:ext cx="1563625" cy="1325881"/>
          </a:xfrm>
          <a:prstGeom prst="rect">
            <a:avLst/>
          </a:prstGeom>
        </p:spPr>
      </p:pic>
      <p:pic>
        <p:nvPicPr>
          <p:cNvPr id="24" name="Picture 23"/>
          <p:cNvPicPr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68" t="2133" r="478" b="41105"/>
          <a:stretch/>
        </p:blipFill>
        <p:spPr>
          <a:xfrm>
            <a:off x="967966" y="9608642"/>
            <a:ext cx="1563625" cy="1325881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08" t="37842" r="22332" b="4785"/>
          <a:stretch/>
        </p:blipFill>
        <p:spPr>
          <a:xfrm>
            <a:off x="2577163" y="8246247"/>
            <a:ext cx="1560969" cy="1325881"/>
          </a:xfrm>
          <a:prstGeom prst="rect">
            <a:avLst/>
          </a:prstGeom>
        </p:spPr>
      </p:pic>
      <p:pic>
        <p:nvPicPr>
          <p:cNvPr id="26" name="Picture 25"/>
          <p:cNvPicPr>
            <a:picLocks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59" t="18408" r="34082" b="24626"/>
          <a:stretch/>
        </p:blipFill>
        <p:spPr>
          <a:xfrm>
            <a:off x="2574507" y="9607052"/>
            <a:ext cx="1563625" cy="1325881"/>
          </a:xfrm>
          <a:prstGeom prst="rect">
            <a:avLst/>
          </a:prstGeom>
        </p:spPr>
      </p:pic>
      <p:pic>
        <p:nvPicPr>
          <p:cNvPr id="27" name="Picture 26"/>
          <p:cNvPicPr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98" t="36011" r="3601" b="7634"/>
          <a:stretch/>
        </p:blipFill>
        <p:spPr>
          <a:xfrm>
            <a:off x="4186939" y="8247954"/>
            <a:ext cx="1563625" cy="1325881"/>
          </a:xfrm>
          <a:prstGeom prst="rect">
            <a:avLst/>
          </a:prstGeom>
        </p:spPr>
      </p:pic>
      <p:pic>
        <p:nvPicPr>
          <p:cNvPr id="28" name="Picture 27"/>
          <p:cNvPicPr>
            <a:picLocks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76" t="21868" r="19012" b="21980"/>
          <a:stretch/>
        </p:blipFill>
        <p:spPr>
          <a:xfrm>
            <a:off x="4186939" y="9607052"/>
            <a:ext cx="1563625" cy="1325881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 rot="16200000" flipH="1">
            <a:off x="472447" y="8742717"/>
            <a:ext cx="630556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/>
              <a:t>0 Gy</a:t>
            </a:r>
          </a:p>
        </p:txBody>
      </p:sp>
      <p:sp>
        <p:nvSpPr>
          <p:cNvPr id="30" name="TextBox 29"/>
          <p:cNvSpPr txBox="1"/>
          <p:nvPr/>
        </p:nvSpPr>
        <p:spPr>
          <a:xfrm rot="16200000" flipH="1">
            <a:off x="424062" y="10001780"/>
            <a:ext cx="805052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1" b="1" dirty="0"/>
              <a:t>4 Gy</a:t>
            </a:r>
          </a:p>
        </p:txBody>
      </p:sp>
      <p:sp>
        <p:nvSpPr>
          <p:cNvPr id="31" name="TextBox 30"/>
          <p:cNvSpPr txBox="1"/>
          <p:nvPr/>
        </p:nvSpPr>
        <p:spPr>
          <a:xfrm flipH="1">
            <a:off x="1242900" y="7925273"/>
            <a:ext cx="1173291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/>
              <a:t>Normoxia</a:t>
            </a:r>
          </a:p>
        </p:txBody>
      </p:sp>
      <p:sp>
        <p:nvSpPr>
          <p:cNvPr id="32" name="TextBox 31"/>
          <p:cNvSpPr txBox="1"/>
          <p:nvPr/>
        </p:nvSpPr>
        <p:spPr>
          <a:xfrm flipH="1">
            <a:off x="2843197" y="7925273"/>
            <a:ext cx="1173291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/>
              <a:t>Acute </a:t>
            </a:r>
            <a:r>
              <a:rPr lang="en-US" sz="1801" b="1" dirty="0" err="1"/>
              <a:t>Hyp</a:t>
            </a:r>
            <a:endParaRPr lang="en-US" sz="1801" b="1" dirty="0"/>
          </a:p>
        </p:txBody>
      </p:sp>
      <p:sp>
        <p:nvSpPr>
          <p:cNvPr id="33" name="TextBox 32"/>
          <p:cNvSpPr txBox="1"/>
          <p:nvPr/>
        </p:nvSpPr>
        <p:spPr>
          <a:xfrm flipH="1">
            <a:off x="4404165" y="7918804"/>
            <a:ext cx="1520859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 err="1"/>
              <a:t>Reoxy</a:t>
            </a:r>
            <a:r>
              <a:rPr lang="en-US" sz="1801" b="1" dirty="0"/>
              <a:t> </a:t>
            </a:r>
            <a:r>
              <a:rPr lang="en-US" sz="1801" b="1" dirty="0" err="1"/>
              <a:t>Hyp</a:t>
            </a:r>
            <a:endParaRPr lang="en-US" sz="1801" b="1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4952580" y="9496070"/>
            <a:ext cx="691468" cy="195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5057070" y="9283571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500 µm</a:t>
            </a:r>
            <a:endParaRPr lang="de-DE" sz="8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512079" y="7940775"/>
            <a:ext cx="330540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 dirty="0"/>
              <a:t>D</a:t>
            </a:r>
            <a:endParaRPr lang="de-DE" sz="1801" b="1" dirty="0"/>
          </a:p>
        </p:txBody>
      </p:sp>
    </p:spTree>
    <p:extLst>
      <p:ext uri="{BB962C8B-B14F-4D97-AF65-F5344CB8AC3E}">
        <p14:creationId xmlns:p14="http://schemas.microsoft.com/office/powerpoint/2010/main" val="23271649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2</Words>
  <Application>Microsoft Macintosh PowerPoint</Application>
  <PresentationFormat>Widescreen</PresentationFormat>
  <Paragraphs>23</Paragraphs>
  <Slides>4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2</vt:i4>
      </vt:variant>
      <vt:variant>
        <vt:lpstr>Titoli diapositive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9</vt:lpstr>
      <vt:lpstr>Prism 8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GSI Helmholtzzentrum für Schwerionenforschung GmbH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artieri, Martina</dc:creator>
  <cp:lastModifiedBy>Utente di Microsoft Office</cp:lastModifiedBy>
  <cp:revision>3</cp:revision>
  <dcterms:created xsi:type="dcterms:W3CDTF">2023-05-12T14:10:30Z</dcterms:created>
  <dcterms:modified xsi:type="dcterms:W3CDTF">2023-10-02T07:34:11Z</dcterms:modified>
</cp:coreProperties>
</file>